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B4FE8F-D571-40D7-A527-64C22249ECB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E46B6-7694-4B67-97F3-E8900110E8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D0429-4A0F-4B97-8608-57B6761AA0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A903A-273F-4C0C-A535-5AF65BF94F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F38B9-EA69-47DA-9DDF-80300BBF15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A70752-92B7-4716-B5B3-00290AB659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68ABF8-5B9F-433B-AE8D-F3C84E6CFA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DA67A-F318-43FF-AF61-B38355FB24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055C0-9863-4FAF-92B8-AE4577B118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5A24CF-D1BE-4B66-B269-49C7279EF0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841B94-9DF3-4F03-AB4C-3623B93ADA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54E758-9143-4912-8285-F510CB62AB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3B95B3-43B0-4801-94FB-2A871F0C101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" Target=""/><Relationship Id="rId2" Type="http://schemas.openxmlformats.org/officeDocument/2006/relationships/slide" Target="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994680" y="689040"/>
            <a:ext cx="4956840" cy="4768920"/>
            <a:chOff x="994680" y="689040"/>
            <a:chExt cx="4956840" cy="4768920"/>
          </a:xfrm>
        </p:grpSpPr>
        <p:sp>
          <p:nvSpPr>
            <p:cNvPr id="42" name="">
              <a:hlinkClick r:id="rId1" action="ppaction://hlinksldjump"/>
            </p:cNvPr>
            <p:cNvSpPr/>
            <p:nvPr/>
          </p:nvSpPr>
          <p:spPr>
            <a:xfrm>
              <a:off x="2321640" y="920880"/>
              <a:ext cx="884880" cy="561240"/>
            </a:xfrm>
            <a:prstGeom prst="flowChartProcess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Selection Proces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385800" y="920880"/>
              <a:ext cx="985320" cy="561240"/>
            </a:xfrm>
            <a:prstGeom prst="flowChartInputOutput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FlyRNAi Data Subse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>
              <a:hlinkClick r:id="rId2" action="ppaction://hlinksldjump"/>
            </p:cNvPr>
            <p:cNvSpPr/>
            <p:nvPr/>
          </p:nvSpPr>
          <p:spPr>
            <a:xfrm>
              <a:off x="4651920" y="920880"/>
              <a:ext cx="843840" cy="561240"/>
            </a:xfrm>
            <a:prstGeom prst="flowChartProcess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Retrieval of </a:t>
              </a:r>
              <a:r>
                <a:rPr b="0" i="1" lang="en-GB" sz="7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 dat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638160" y="1724760"/>
              <a:ext cx="985680" cy="561240"/>
            </a:xfrm>
            <a:prstGeom prst="flowChartInputOutput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700" spc="-1" strike="noStrike">
                  <a:solidFill>
                    <a:srgbClr val="000000"/>
                  </a:solidFill>
                  <a:latin typeface="Arial"/>
                </a:rPr>
                <a:t>D. mel. </a:t>
              </a: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AA sequence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714120" y="2519640"/>
              <a:ext cx="838080" cy="561240"/>
            </a:xfrm>
            <a:prstGeom prst="flowChartProcess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TBLASTN Search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965480" y="2519640"/>
              <a:ext cx="986040" cy="561240"/>
            </a:xfrm>
            <a:prstGeom prst="flowChartInputOutput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700" spc="-1" strike="noStrike">
                  <a:solidFill>
                    <a:srgbClr val="000000"/>
                  </a:solidFill>
                  <a:latin typeface="Arial"/>
                </a:rPr>
                <a:t>R. microplus</a:t>
              </a: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 EST/TC sequence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642480" y="3296880"/>
              <a:ext cx="985680" cy="560160"/>
            </a:xfrm>
            <a:prstGeom prst="flowChartInputOutput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700" spc="-1" strike="noStrike">
                  <a:solidFill>
                    <a:srgbClr val="000000"/>
                  </a:solidFill>
                  <a:latin typeface="Arial"/>
                </a:rPr>
                <a:t>R. microplus</a:t>
              </a: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 hit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994680" y="4896720"/>
              <a:ext cx="985320" cy="561240"/>
            </a:xfrm>
            <a:prstGeom prst="flowChartInputOutput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Annotated </a:t>
              </a:r>
              <a:r>
                <a:rPr b="1" i="1" lang="en-GB" sz="700" spc="-1" strike="noStrike">
                  <a:solidFill>
                    <a:srgbClr val="000000"/>
                  </a:solidFill>
                  <a:latin typeface="Arial"/>
                </a:rPr>
                <a:t>R. microplus</a:t>
              </a: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 sequence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872960" y="4119840"/>
              <a:ext cx="985320" cy="560520"/>
            </a:xfrm>
            <a:prstGeom prst="flowChartInputOutpu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700" spc="-1" strike="noStrike">
                  <a:solidFill>
                    <a:srgbClr val="000000"/>
                  </a:solidFill>
                  <a:latin typeface="Arial"/>
                </a:rPr>
                <a:t>R. microplus</a:t>
              </a: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 phenotype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1" name=""/>
            <p:cNvCxnSpPr>
              <a:stCxn id="45" idx="4"/>
              <a:endCxn id="46" idx="0"/>
            </p:cNvCxnSpPr>
            <p:nvPr/>
          </p:nvCxnSpPr>
          <p:spPr>
            <a:xfrm>
              <a:off x="4131000" y="2286000"/>
              <a:ext cx="2520" cy="2340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2" name=""/>
            <p:cNvCxnSpPr>
              <a:stCxn id="46" idx="2"/>
              <a:endCxn id="48" idx="1"/>
            </p:cNvCxnSpPr>
            <p:nvPr/>
          </p:nvCxnSpPr>
          <p:spPr>
            <a:xfrm>
              <a:off x="4133160" y="3080880"/>
              <a:ext cx="2520" cy="2163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3" name=""/>
            <p:cNvCxnSpPr>
              <a:stCxn id="44" idx="2"/>
              <a:endCxn id="45" idx="1"/>
            </p:cNvCxnSpPr>
            <p:nvPr/>
          </p:nvCxnSpPr>
          <p:spPr>
            <a:xfrm rot="5400000">
              <a:off x="4480920" y="1132200"/>
              <a:ext cx="243000" cy="943200"/>
            </a:xfrm>
            <a:prstGeom prst="bentConnector5">
              <a:avLst>
                <a:gd name="adj1" fmla="val 95252"/>
                <a:gd name="adj2" fmla="val -69339"/>
                <a:gd name="adj3" fmla="val -326854"/>
              </a:avLst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4" name=""/>
            <p:cNvCxnSpPr>
              <a:stCxn id="43" idx="5"/>
              <a:endCxn id="44" idx="1"/>
            </p:cNvCxnSpPr>
            <p:nvPr/>
          </p:nvCxnSpPr>
          <p:spPr>
            <a:xfrm>
              <a:off x="4271040" y="1201320"/>
              <a:ext cx="381240" cy="3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5" name=""/>
            <p:cNvCxnSpPr>
              <a:stCxn id="42" idx="3"/>
              <a:endCxn id="43" idx="2"/>
            </p:cNvCxnSpPr>
            <p:nvPr/>
          </p:nvCxnSpPr>
          <p:spPr>
            <a:xfrm>
              <a:off x="3206520" y="1201320"/>
              <a:ext cx="277920" cy="3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6" name=""/>
            <p:cNvSpPr/>
            <p:nvPr/>
          </p:nvSpPr>
          <p:spPr>
            <a:xfrm>
              <a:off x="5010840" y="3296880"/>
              <a:ext cx="731160" cy="560160"/>
            </a:xfrm>
            <a:prstGeom prst="flowChartProcess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dsRNA desig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7" name=""/>
            <p:cNvCxnSpPr>
              <a:stCxn id="48" idx="5"/>
              <a:endCxn id="56" idx="1"/>
            </p:cNvCxnSpPr>
            <p:nvPr/>
          </p:nvCxnSpPr>
          <p:spPr>
            <a:xfrm>
              <a:off x="4528080" y="3576960"/>
              <a:ext cx="483120" cy="3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8" name=""/>
            <p:cNvCxnSpPr>
              <a:stCxn id="56" idx="2"/>
              <a:endCxn id="50" idx="1"/>
            </p:cNvCxnSpPr>
            <p:nvPr/>
          </p:nvCxnSpPr>
          <p:spPr>
            <a:xfrm flipH="1">
              <a:off x="5365800" y="3857040"/>
              <a:ext cx="11160" cy="263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9" name=""/>
            <p:cNvSpPr/>
            <p:nvPr/>
          </p:nvSpPr>
          <p:spPr>
            <a:xfrm>
              <a:off x="2361240" y="1730520"/>
              <a:ext cx="985320" cy="561240"/>
            </a:xfrm>
            <a:prstGeom prst="flowChartInputOutput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700" spc="-1" strike="noStrike">
                  <a:solidFill>
                    <a:srgbClr val="000000"/>
                  </a:solidFill>
                  <a:latin typeface="Arial"/>
                </a:rPr>
                <a:t>D. mel.</a:t>
              </a:r>
              <a:r>
                <a:rPr b="0" i="1" lang="en-GB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GO Dat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714120" y="4119840"/>
              <a:ext cx="843480" cy="560520"/>
            </a:xfrm>
            <a:prstGeom prst="flowChartProcess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InterPro search for conserved functional domain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1" name=""/>
            <p:cNvCxnSpPr>
              <a:stCxn id="48" idx="4"/>
              <a:endCxn id="60" idx="0"/>
            </p:cNvCxnSpPr>
            <p:nvPr/>
          </p:nvCxnSpPr>
          <p:spPr>
            <a:xfrm>
              <a:off x="4135320" y="3857040"/>
              <a:ext cx="1080" cy="263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62" name=""/>
            <p:cNvSpPr/>
            <p:nvPr/>
          </p:nvSpPr>
          <p:spPr>
            <a:xfrm>
              <a:off x="2407680" y="4119840"/>
              <a:ext cx="985320" cy="560520"/>
            </a:xfrm>
            <a:prstGeom prst="flowChartInputOutput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InterPro Hit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199160" y="4119840"/>
              <a:ext cx="578160" cy="561240"/>
            </a:xfrm>
            <a:prstGeom prst="flowChartProcess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Annotatio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4" name=""/>
            <p:cNvCxnSpPr>
              <a:stCxn id="63" idx="2"/>
              <a:endCxn id="49" idx="1"/>
            </p:cNvCxnSpPr>
            <p:nvPr/>
          </p:nvCxnSpPr>
          <p:spPr>
            <a:xfrm flipH="1">
              <a:off x="1487520" y="4681080"/>
              <a:ext cx="1080" cy="2160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5" name=""/>
            <p:cNvCxnSpPr>
              <a:stCxn id="62" idx="2"/>
              <a:endCxn id="63" idx="3"/>
            </p:cNvCxnSpPr>
            <p:nvPr/>
          </p:nvCxnSpPr>
          <p:spPr>
            <a:xfrm flipH="1">
              <a:off x="1777320" y="4400280"/>
              <a:ext cx="729000" cy="3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6" name=""/>
            <p:cNvCxnSpPr>
              <a:stCxn id="60" idx="1"/>
              <a:endCxn id="62" idx="5"/>
            </p:cNvCxnSpPr>
            <p:nvPr/>
          </p:nvCxnSpPr>
          <p:spPr>
            <a:xfrm flipH="1">
              <a:off x="3292920" y="4400280"/>
              <a:ext cx="421560" cy="3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7" name=""/>
            <p:cNvCxnSpPr>
              <a:stCxn id="44" idx="2"/>
              <a:endCxn id="59" idx="0"/>
            </p:cNvCxnSpPr>
            <p:nvPr/>
          </p:nvCxnSpPr>
          <p:spPr>
            <a:xfrm rot="5400000">
              <a:off x="3888720" y="545760"/>
              <a:ext cx="248760" cy="2121840"/>
            </a:xfrm>
            <a:prstGeom prst="bentConnector5">
              <a:avLst>
                <a:gd name="adj1" fmla="val 93043"/>
                <a:gd name="adj2" fmla="val 50653"/>
                <a:gd name="adj3" fmla="val 6521"/>
              </a:avLst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8" name=""/>
            <p:cNvCxnSpPr>
              <a:stCxn id="59" idx="4"/>
              <a:endCxn id="63" idx="0"/>
            </p:cNvCxnSpPr>
            <p:nvPr/>
          </p:nvCxnSpPr>
          <p:spPr>
            <a:xfrm rot="5400000">
              <a:off x="1257120" y="2522880"/>
              <a:ext cx="1828440" cy="1366200"/>
            </a:xfrm>
            <a:prstGeom prst="bentConnector3">
              <a:avLst>
                <a:gd name="adj1" fmla="val 49980"/>
              </a:avLst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9" name=""/>
            <p:cNvCxnSpPr>
              <a:stCxn id="47" idx="2"/>
              <a:endCxn id="46" idx="3"/>
            </p:cNvCxnSpPr>
            <p:nvPr/>
          </p:nvCxnSpPr>
          <p:spPr>
            <a:xfrm flipH="1">
              <a:off x="4552200" y="2800080"/>
              <a:ext cx="512280" cy="3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70" name=""/>
            <p:cNvSpPr/>
            <p:nvPr/>
          </p:nvSpPr>
          <p:spPr>
            <a:xfrm>
              <a:off x="1066320" y="920880"/>
              <a:ext cx="1090080" cy="561240"/>
            </a:xfrm>
            <a:prstGeom prst="flowChartInputOutput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6880" rIns="56880" tIns="28440" bIns="284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FlyRNAi Dat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1" name=""/>
            <p:cNvCxnSpPr>
              <a:stCxn id="70" idx="5"/>
              <a:endCxn id="42" idx="1"/>
            </p:cNvCxnSpPr>
            <p:nvPr/>
          </p:nvCxnSpPr>
          <p:spPr>
            <a:xfrm>
              <a:off x="2045520" y="1201320"/>
              <a:ext cx="276480" cy="3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</p:grpSp>
      <p:sp>
        <p:nvSpPr>
          <p:cNvPr id="72" name=""/>
          <p:cNvSpPr/>
          <p:nvPr/>
        </p:nvSpPr>
        <p:spPr>
          <a:xfrm>
            <a:off x="5622840" y="73080"/>
            <a:ext cx="119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Kurscheid 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831040" y="5816520"/>
            <a:ext cx="126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Additional Fil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8-19T09:06:07Z</dcterms:created>
  <dc:creator>Sebastian Kurscheid</dc:creator>
  <dc:description/>
  <dc:language>en-US</dc:language>
  <cp:lastModifiedBy>lewa</cp:lastModifiedBy>
  <dcterms:modified xsi:type="dcterms:W3CDTF">2009-01-07T08:44:36Z</dcterms:modified>
  <cp:revision>3</cp:revision>
  <dc:subject/>
  <dc:title>Slide 1</dc:title>
</cp:coreProperties>
</file>